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60" r:id="rId4"/>
    <p:sldId id="263" r:id="rId5"/>
    <p:sldId id="257" r:id="rId6"/>
    <p:sldId id="262" r:id="rId7"/>
    <p:sldId id="259" r:id="rId8"/>
    <p:sldId id="261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368" autoAdjust="0"/>
    <p:restoredTop sz="94660"/>
  </p:normalViewPr>
  <p:slideViewPr>
    <p:cSldViewPr snapToGrid="0">
      <p:cViewPr varScale="1">
        <p:scale>
          <a:sx n="72" d="100"/>
          <a:sy n="72" d="100"/>
        </p:scale>
        <p:origin x="10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FE5404-E345-B433-6860-DACE12BBD5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C7FA3FD-766B-0EF4-3DCA-96EED7A624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CFE6F6-4AA1-71CC-AA77-28A6B621E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A6AD01-0BC2-98BD-DFFB-23E924FD8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116C5-14DF-B161-D48B-885B6AB998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0379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33E7AC-C190-10C5-77B4-09BB663EC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716102-683F-B438-6FF3-45A3379036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BFF356-DBFB-B6B7-2E55-50D1DD110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1EAE70-1B3A-9C41-E2B1-35F48419E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08EC27-CA71-D94C-EB04-25B930FEDF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9388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1684A7-78F3-D3AF-330A-3D19C8435A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5DDE60-8E0C-31F1-CA7D-6CB7FB2BFB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E9095A-58A2-1A99-5861-E683C8B7B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4A3530-0424-AB23-A263-F4D1A2E6A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A18850-E7F9-A4C0-6730-2BFF41A0A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7311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737283-9B5A-0EDC-5874-9927236BD5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40CB7D-E5E8-156A-46D1-FB958C4AFE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4E41C4-ED0A-5263-FE71-173FD3904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00A110-7E15-FE66-7589-BBA1A76F7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AE7CB8-C1A8-A24E-A085-1F8116D7A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28867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EC6EF6-8634-57A9-9DA3-923DE0D1B1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B06031-C3F0-9B04-80DF-E0FEE50CE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76269D-3495-0039-52E0-47CAA4C3F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02DBD6-A058-9EA3-A4B6-F7A8ED743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F1380C-6552-CE48-0EF8-7B25C744A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34927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C0AB98-1483-419B-688D-C6E2AB3689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E325D1-8BA7-ED42-03A8-711AD95F92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6F8BE2-396C-1A26-FF63-AECAABEFC4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A951A1-E05E-3D54-0831-2B96BD209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4B5A1A-93D7-91F6-13BF-90911E4FE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9FC0AC-BC8C-74B4-F134-767EE1311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3808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865EE-06C7-8210-6080-377728B14A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1987B5-BC90-95DC-44E6-4339A4040F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046347-F964-B118-7E4C-5855007FC6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40D758-A912-309C-9E1F-BDD1AF269B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1C44EE-9249-0E50-F116-B90D77880A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9DA4746-0E31-A283-1813-04C02449D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6CC7CC-A478-0B90-A2D8-80A84D09E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81DA80-D160-0416-F600-2EB7A7690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30423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6EBD0F-294B-C2DB-D4F1-8521141049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A1D6F1-01B1-2643-D674-66FD7CE61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CC3547-6DB2-B474-1308-798955CEC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93A81A6-DB87-0A25-312F-B3D6B46D4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3159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F2A32E-3E15-8E90-16F5-1B766286E3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A391991-C3B0-958D-1E03-E3132AA3B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C14036-D58B-5B53-CDFC-83B88855A0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43603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07A97-42DF-85CC-1C55-9E41992163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37C330-3035-F204-FDA2-4AE6FBC1DD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DD12A2-268C-78C9-88E3-D02E5A59E7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07F08E-57F5-EBD2-98C8-A102172AE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2C74AE-6606-83C5-D7C5-236D5DDEE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1B77EE-0DB0-377A-AC1A-AE0258405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77406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DCEDD-071F-3F78-809C-23B4AB180D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31E64A7-C204-54D0-82BB-990C05EE51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9D97BC-FCC7-E6C7-872D-C045C02F6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9D5AC5-46A8-B66C-74CB-E7CBE9B8B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8F10E1-F5A9-00B7-2317-ADDB96056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A213BF-DEC6-7F7B-F299-38A6744F7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19859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E67080-0A7F-FBA8-D3C4-E4C0CC5172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3D1A50-67A8-C0A7-5D6C-0E55F7E542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279B4-C671-60E7-7D90-9FF4C2EC0D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7AACA2-70F4-4535-8653-9548EFB24E06}" type="datetimeFigureOut">
              <a:rPr lang="en-IN" smtClean="0"/>
              <a:t>10-03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B32D2C-535C-768E-67C6-C7DC35BB70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FCBB28-6BF1-47B3-444F-0DEF553536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1FF4FE-F011-4A6E-AC48-E27A952B3A1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49779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7B558B0A-4F5C-D975-FEF0-B542E17162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1371707"/>
              </p:ext>
            </p:extLst>
          </p:nvPr>
        </p:nvGraphicFramePr>
        <p:xfrm>
          <a:off x="3463234" y="1753336"/>
          <a:ext cx="4744148" cy="296672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723454">
                  <a:extLst>
                    <a:ext uri="{9D8B030D-6E8A-4147-A177-3AD203B41FA5}">
                      <a16:colId xmlns:a16="http://schemas.microsoft.com/office/drawing/2014/main" val="3559739265"/>
                    </a:ext>
                  </a:extLst>
                </a:gridCol>
                <a:gridCol w="1190942">
                  <a:extLst>
                    <a:ext uri="{9D8B030D-6E8A-4147-A177-3AD203B41FA5}">
                      <a16:colId xmlns:a16="http://schemas.microsoft.com/office/drawing/2014/main" val="1280724908"/>
                    </a:ext>
                  </a:extLst>
                </a:gridCol>
                <a:gridCol w="1829752">
                  <a:extLst>
                    <a:ext uri="{9D8B030D-6E8A-4147-A177-3AD203B41FA5}">
                      <a16:colId xmlns:a16="http://schemas.microsoft.com/office/drawing/2014/main" val="410858397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Transcrip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Sample 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Number of reads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6797515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IN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TL_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6751915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dirty="0"/>
                        <a:t>HOXD11-AGAP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TL_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1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4649410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IN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TL_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6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65585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IN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TL_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3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947871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dirty="0"/>
                        <a:t>BCR-ABL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TL_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2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5997465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IN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TL_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77130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KMT2A-MLLT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TL_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dirty="0"/>
                        <a:t>1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0370551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3B83F07-B35C-842F-E382-FE5838962218}"/>
              </a:ext>
            </a:extLst>
          </p:cNvPr>
          <p:cNvSpPr txBox="1"/>
          <p:nvPr/>
        </p:nvSpPr>
        <p:spPr>
          <a:xfrm>
            <a:off x="4081669" y="0"/>
            <a:ext cx="2809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</a:p>
        </p:txBody>
      </p:sp>
    </p:spTree>
    <p:extLst>
      <p:ext uri="{BB962C8B-B14F-4D97-AF65-F5344CB8AC3E}">
        <p14:creationId xmlns:p14="http://schemas.microsoft.com/office/powerpoint/2010/main" val="26280160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616B9DE-D25A-3DC1-9587-A794A8415C9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82" b="5214"/>
          <a:stretch/>
        </p:blipFill>
        <p:spPr>
          <a:xfrm>
            <a:off x="0" y="525498"/>
            <a:ext cx="12192000" cy="57807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0BA0925-4B5E-87D4-650F-6FC289AA2BCA}"/>
              </a:ext>
            </a:extLst>
          </p:cNvPr>
          <p:cNvSpPr txBox="1"/>
          <p:nvPr/>
        </p:nvSpPr>
        <p:spPr>
          <a:xfrm>
            <a:off x="4903304" y="0"/>
            <a:ext cx="2994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</p:spTree>
    <p:extLst>
      <p:ext uri="{BB962C8B-B14F-4D97-AF65-F5344CB8AC3E}">
        <p14:creationId xmlns:p14="http://schemas.microsoft.com/office/powerpoint/2010/main" val="2202854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4ED308C-D4A3-8994-880E-F1BDC53F95EA}"/>
              </a:ext>
            </a:extLst>
          </p:cNvPr>
          <p:cNvSpPr txBox="1"/>
          <p:nvPr/>
        </p:nvSpPr>
        <p:spPr>
          <a:xfrm>
            <a:off x="4081668" y="0"/>
            <a:ext cx="31142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a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0F835C1-BD23-8C6A-14A5-5B8F984584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25498"/>
            <a:ext cx="12192000" cy="58070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18138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4A947DF-DE4E-3A77-8D29-DED0EA818C84}"/>
              </a:ext>
            </a:extLst>
          </p:cNvPr>
          <p:cNvSpPr txBox="1"/>
          <p:nvPr/>
        </p:nvSpPr>
        <p:spPr>
          <a:xfrm>
            <a:off x="4081668" y="0"/>
            <a:ext cx="31142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5B0A918-6B05-7A49-83E1-7D9806D38D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05" y="1099930"/>
            <a:ext cx="6154496" cy="134758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390A925-9340-4C4A-135A-FB38B85A63C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750"/>
          <a:stretch/>
        </p:blipFill>
        <p:spPr>
          <a:xfrm>
            <a:off x="6268278" y="993913"/>
            <a:ext cx="5923722" cy="211536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1971798-9D94-F310-AF65-59EF87C03800}"/>
              </a:ext>
            </a:extLst>
          </p:cNvPr>
          <p:cNvSpPr txBox="1"/>
          <p:nvPr/>
        </p:nvSpPr>
        <p:spPr>
          <a:xfrm>
            <a:off x="4374149" y="591450"/>
            <a:ext cx="3684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HOXD11 : </a:t>
            </a:r>
            <a:r>
              <a:rPr lang="en-IN" b="1" dirty="0" err="1"/>
              <a:t>Homoebox</a:t>
            </a:r>
            <a:r>
              <a:rPr lang="en-IN" b="1" dirty="0"/>
              <a:t> domain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4256C918-6B36-5A16-C9C4-10B3BDAA3C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705" y="4219575"/>
            <a:ext cx="5762625" cy="263842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188D52A-8B4C-3B3B-C33A-553B81C97CE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37664"/>
          <a:stretch/>
        </p:blipFill>
        <p:spPr>
          <a:xfrm>
            <a:off x="5975798" y="4219575"/>
            <a:ext cx="6154497" cy="228065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0B4866D-59E3-2BA3-C084-B3864B131A41}"/>
              </a:ext>
            </a:extLst>
          </p:cNvPr>
          <p:cNvSpPr txBox="1"/>
          <p:nvPr/>
        </p:nvSpPr>
        <p:spPr>
          <a:xfrm>
            <a:off x="4253947" y="3564054"/>
            <a:ext cx="4333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AGAP3: </a:t>
            </a:r>
            <a:r>
              <a:rPr lang="en-IN" b="1" dirty="0" err="1"/>
              <a:t>arf</a:t>
            </a:r>
            <a:r>
              <a:rPr lang="en-IN" b="1" dirty="0"/>
              <a:t>-GAP with GTPase domain</a:t>
            </a:r>
          </a:p>
        </p:txBody>
      </p:sp>
    </p:spTree>
    <p:extLst>
      <p:ext uri="{BB962C8B-B14F-4D97-AF65-F5344CB8AC3E}">
        <p14:creationId xmlns:p14="http://schemas.microsoft.com/office/powerpoint/2010/main" val="23618074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A289AC20-426B-F689-0399-6F17AE88B3ED}"/>
              </a:ext>
            </a:extLst>
          </p:cNvPr>
          <p:cNvSpPr txBox="1"/>
          <p:nvPr/>
        </p:nvSpPr>
        <p:spPr>
          <a:xfrm>
            <a:off x="4081669" y="0"/>
            <a:ext cx="2968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9D80CA8-B9C7-5D80-1464-0C6831073E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000"/>
          <a:stretch/>
        </p:blipFill>
        <p:spPr>
          <a:xfrm>
            <a:off x="1219200" y="525498"/>
            <a:ext cx="9753600" cy="58070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91710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4ED308C-D4A3-8994-880E-F1BDC53F95EA}"/>
              </a:ext>
            </a:extLst>
          </p:cNvPr>
          <p:cNvSpPr txBox="1"/>
          <p:nvPr/>
        </p:nvSpPr>
        <p:spPr>
          <a:xfrm>
            <a:off x="4081669" y="0"/>
            <a:ext cx="30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C7A39A8-5DF8-1250-68C9-3524608562B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74" r="29022"/>
          <a:stretch/>
        </p:blipFill>
        <p:spPr>
          <a:xfrm rot="16200000">
            <a:off x="2981614" y="-127500"/>
            <a:ext cx="6488668" cy="74823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32674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232082F-ED9F-76B9-32A9-202AE1BC4EE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2629"/>
          <a:stretch/>
        </p:blipFill>
        <p:spPr>
          <a:xfrm rot="5400000">
            <a:off x="4558749" y="1404212"/>
            <a:ext cx="5832676" cy="404957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7B68063-6E73-3ADA-9FA4-D31E60DCC6F1}"/>
              </a:ext>
            </a:extLst>
          </p:cNvPr>
          <p:cNvSpPr txBox="1"/>
          <p:nvPr/>
        </p:nvSpPr>
        <p:spPr>
          <a:xfrm>
            <a:off x="2402299" y="1775792"/>
            <a:ext cx="30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Regulation of gene express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4B83256-6266-4937-E763-27AE15F16DB6}"/>
              </a:ext>
            </a:extLst>
          </p:cNvPr>
          <p:cNvSpPr txBox="1"/>
          <p:nvPr/>
        </p:nvSpPr>
        <p:spPr>
          <a:xfrm>
            <a:off x="2402299" y="2761923"/>
            <a:ext cx="304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RUNX3 mediated regulation of Immune respons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85B6E5E-20A0-326F-DAEA-21D219B22F03}"/>
              </a:ext>
            </a:extLst>
          </p:cNvPr>
          <p:cNvSpPr txBox="1"/>
          <p:nvPr/>
        </p:nvSpPr>
        <p:spPr>
          <a:xfrm>
            <a:off x="2009876" y="4046362"/>
            <a:ext cx="3726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Regulation of beta-cell developmen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AD91DA-34ED-7462-EFB2-6122C9813083}"/>
              </a:ext>
            </a:extLst>
          </p:cNvPr>
          <p:cNvSpPr txBox="1"/>
          <p:nvPr/>
        </p:nvSpPr>
        <p:spPr>
          <a:xfrm>
            <a:off x="3352800" y="5103517"/>
            <a:ext cx="2436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Collagen Biosynthesi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4ED308C-D4A3-8994-880E-F1BDC53F95EA}"/>
              </a:ext>
            </a:extLst>
          </p:cNvPr>
          <p:cNvSpPr txBox="1"/>
          <p:nvPr/>
        </p:nvSpPr>
        <p:spPr>
          <a:xfrm>
            <a:off x="4081669" y="0"/>
            <a:ext cx="30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</p:spTree>
    <p:extLst>
      <p:ext uri="{BB962C8B-B14F-4D97-AF65-F5344CB8AC3E}">
        <p14:creationId xmlns:p14="http://schemas.microsoft.com/office/powerpoint/2010/main" val="21220832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F4ED308C-D4A3-8994-880E-F1BDC53F95EA}"/>
              </a:ext>
            </a:extLst>
          </p:cNvPr>
          <p:cNvSpPr txBox="1"/>
          <p:nvPr/>
        </p:nvSpPr>
        <p:spPr>
          <a:xfrm>
            <a:off x="4081669" y="0"/>
            <a:ext cx="30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69BD31B-9078-DE75-8FBC-72173E4AB26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282"/>
          <a:stretch/>
        </p:blipFill>
        <p:spPr>
          <a:xfrm>
            <a:off x="0" y="1101658"/>
            <a:ext cx="12192000" cy="4861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0189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</TotalTime>
  <Words>87</Words>
  <Application>Microsoft Office PowerPoint</Application>
  <PresentationFormat>Widescreen</PresentationFormat>
  <Paragraphs>3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gar Desai</dc:creator>
  <cp:lastModifiedBy>Sagar Desai</cp:lastModifiedBy>
  <cp:revision>12</cp:revision>
  <dcterms:created xsi:type="dcterms:W3CDTF">2022-11-16T20:42:54Z</dcterms:created>
  <dcterms:modified xsi:type="dcterms:W3CDTF">2023-03-10T06:30:51Z</dcterms:modified>
</cp:coreProperties>
</file>